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media/image3.jpeg" ContentType="image/jpeg"/>
  <Override PartName="/ppt/media/image4.jpeg" ContentType="image/jpeg"/>
  <Override PartName="/ppt/media/image5.png" ContentType="image/png"/>
  <Override PartName="/ppt/media/image6.png" ContentType="image/png"/>
  <Override PartName="/ppt/media/image7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80072D-C157-4BF5-8162-C087BAC47E0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C3B79E-2826-4C8B-A421-CC42D29E8F2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EEDE76-82BD-4E48-B5F0-D509E18CB7D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FD743B-E7C6-419C-A89B-6C1736EFB63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721971-35F1-4BC0-B72E-6E5D7C9517A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A88491-A28D-4D95-A60A-F9590DBB5E3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E669A6-12B5-4B84-A4A1-3D2282B8F7B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A0AEA3-7037-47FA-8698-7E6E5FA7D31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44FB7F-8A4E-40D0-95F7-FA05AAC9528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1FF0F1-4D17-4502-88FD-8D161C49715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D4839D-2A8C-493B-8A8E-D031791C74C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A519E5-B5D6-4091-86F4-763F454DFE3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it-I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it-I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0A78C97D-AAAA-44A5-A2FD-4C86E3105C94}" type="slidenum">
              <a:rPr b="0" lang="it-IT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uppo 1"/>
          <p:cNvGrpSpPr/>
          <p:nvPr/>
        </p:nvGrpSpPr>
        <p:grpSpPr>
          <a:xfrm>
            <a:off x="-55440" y="0"/>
            <a:ext cx="6913440" cy="8881920"/>
            <a:chOff x="-55440" y="0"/>
            <a:chExt cx="6913440" cy="8881920"/>
          </a:xfrm>
        </p:grpSpPr>
        <p:pic>
          <p:nvPicPr>
            <p:cNvPr id="42" name="Immagine 5" descr=""/>
            <p:cNvPicPr/>
            <p:nvPr/>
          </p:nvPicPr>
          <p:blipFill>
            <a:blip r:embed="rId1"/>
            <a:stretch/>
          </p:blipFill>
          <p:spPr>
            <a:xfrm>
              <a:off x="161280" y="1187280"/>
              <a:ext cx="3290760" cy="20638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3" name="CasellaDiTesto 6"/>
            <p:cNvSpPr/>
            <p:nvPr/>
          </p:nvSpPr>
          <p:spPr>
            <a:xfrm>
              <a:off x="-55440" y="0"/>
              <a:ext cx="6913440" cy="642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800" spc="-1" strike="noStrike">
                  <a:solidFill>
                    <a:srgbClr val="000000"/>
                  </a:solidFill>
                  <a:latin typeface="Arial"/>
                  <a:ea typeface="Arial"/>
                </a:rPr>
                <a:t>Figure S5. </a:t>
              </a:r>
              <a:r>
                <a:rPr b="1" lang="en-GB" sz="1800" spc="-1" strike="noStrike">
                  <a:solidFill>
                    <a:srgbClr val="000000"/>
                  </a:solidFill>
                  <a:latin typeface="Arial"/>
                  <a:ea typeface="Arial"/>
                </a:rPr>
                <a:t>Caspase-3 and Caspase-8 are specifically activated in stimulated Th1 clones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44" name="Immagine 3" descr=""/>
            <p:cNvPicPr/>
            <p:nvPr/>
          </p:nvPicPr>
          <p:blipFill>
            <a:blip r:embed="rId2"/>
            <a:stretch/>
          </p:blipFill>
          <p:spPr>
            <a:xfrm>
              <a:off x="3340440" y="1035720"/>
              <a:ext cx="3322440" cy="23202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5" name="CasellaDiTesto 4"/>
            <p:cNvSpPr/>
            <p:nvPr/>
          </p:nvSpPr>
          <p:spPr>
            <a:xfrm>
              <a:off x="161280" y="3781800"/>
              <a:ext cx="5040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it-IT" sz="1800" spc="-1" strike="noStrike">
                  <a:solidFill>
                    <a:srgbClr val="000000"/>
                  </a:solidFill>
                  <a:latin typeface="Calibri"/>
                </a:rPr>
                <a:t>C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46" name="Picture 2" descr=""/>
            <p:cNvPicPr/>
            <p:nvPr/>
          </p:nvPicPr>
          <p:blipFill>
            <a:blip r:embed="rId3"/>
            <a:srcRect l="25137" t="44051" r="32310" b="8443"/>
            <a:stretch/>
          </p:blipFill>
          <p:spPr>
            <a:xfrm>
              <a:off x="1066680" y="7725600"/>
              <a:ext cx="1758600" cy="586080"/>
            </a:xfrm>
            <a:prstGeom prst="rect">
              <a:avLst/>
            </a:prstGeom>
            <a:ln w="9360">
              <a:solidFill>
                <a:srgbClr val="000000">
                  <a:alpha val="98000"/>
                </a:srgbClr>
              </a:solidFill>
              <a:miter/>
            </a:ln>
          </p:spPr>
        </p:pic>
        <p:pic>
          <p:nvPicPr>
            <p:cNvPr id="47" name="Immagine 8" descr=""/>
            <p:cNvPicPr/>
            <p:nvPr/>
          </p:nvPicPr>
          <p:blipFill>
            <a:blip r:embed="rId4"/>
            <a:stretch/>
          </p:blipFill>
          <p:spPr>
            <a:xfrm>
              <a:off x="1066680" y="8386920"/>
              <a:ext cx="1783440" cy="49500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sp>
          <p:nvSpPr>
            <p:cNvPr id="48" name="CasellaDiTesto 9"/>
            <p:cNvSpPr/>
            <p:nvPr/>
          </p:nvSpPr>
          <p:spPr>
            <a:xfrm>
              <a:off x="1173960" y="4199040"/>
              <a:ext cx="175860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it-IT" sz="2400" spc="-1" strike="noStrike">
                  <a:solidFill>
                    <a:srgbClr val="000000"/>
                  </a:solidFill>
                  <a:latin typeface="Calibri"/>
                </a:rPr>
                <a:t>-    </a:t>
              </a:r>
              <a:r>
                <a:rPr b="0" lang="it-IT" sz="2000" spc="-1" strike="noStrike">
                  <a:solidFill>
                    <a:srgbClr val="000000"/>
                  </a:solidFill>
                  <a:latin typeface="Calibri"/>
                </a:rPr>
                <a:t>+</a:t>
              </a:r>
              <a:r>
                <a:rPr b="0" lang="it-IT" sz="2400" spc="-1" strike="noStrike">
                  <a:solidFill>
                    <a:srgbClr val="000000"/>
                  </a:solidFill>
                  <a:latin typeface="Calibri"/>
                </a:rPr>
                <a:t>     -     </a:t>
              </a:r>
              <a:r>
                <a:rPr b="0" lang="it-IT" sz="2000" spc="-1" strike="noStrike">
                  <a:solidFill>
                    <a:srgbClr val="000000"/>
                  </a:solidFill>
                  <a:latin typeface="Calibri"/>
                </a:rPr>
                <a:t>+</a:t>
              </a:r>
              <a:endParaRPr b="0" lang="en-US" sz="2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" name="CasellaDiTesto 10"/>
            <p:cNvSpPr/>
            <p:nvPr/>
          </p:nvSpPr>
          <p:spPr>
            <a:xfrm>
              <a:off x="161280" y="4337640"/>
              <a:ext cx="983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it-IT" sz="1200" spc="-1" strike="noStrike">
                  <a:solidFill>
                    <a:srgbClr val="000000"/>
                  </a:solidFill>
                  <a:latin typeface="Calibri"/>
                </a:rPr>
                <a:t>antiCD3-28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" name="Connettore 1 11"/>
            <p:cNvSpPr/>
            <p:nvPr/>
          </p:nvSpPr>
          <p:spPr>
            <a:xfrm>
              <a:off x="1100520" y="4337640"/>
              <a:ext cx="8186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" name="Connettore 1 12"/>
            <p:cNvSpPr/>
            <p:nvPr/>
          </p:nvSpPr>
          <p:spPr>
            <a:xfrm>
              <a:off x="2004840" y="4337640"/>
              <a:ext cx="8186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" name="CasellaDiTesto 13"/>
            <p:cNvSpPr/>
            <p:nvPr/>
          </p:nvSpPr>
          <p:spPr>
            <a:xfrm>
              <a:off x="1241640" y="4054680"/>
              <a:ext cx="98316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it-IT" sz="1600" spc="-1" strike="noStrike">
                  <a:solidFill>
                    <a:srgbClr val="000000"/>
                  </a:solidFill>
                  <a:latin typeface="Calibri"/>
                </a:rPr>
                <a:t>Th1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" name="CasellaDiTesto 14"/>
            <p:cNvSpPr/>
            <p:nvPr/>
          </p:nvSpPr>
          <p:spPr>
            <a:xfrm>
              <a:off x="2090160" y="4037760"/>
              <a:ext cx="98316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it-IT" sz="1600" spc="-1" strike="noStrike">
                  <a:solidFill>
                    <a:srgbClr val="000000"/>
                  </a:solidFill>
                  <a:latin typeface="Calibri"/>
                </a:rPr>
                <a:t>Th17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" name="CasellaDiTesto 15"/>
            <p:cNvSpPr/>
            <p:nvPr/>
          </p:nvSpPr>
          <p:spPr>
            <a:xfrm>
              <a:off x="2874240" y="7826400"/>
              <a:ext cx="15220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it-IT" sz="1400" spc="-1" strike="noStrike">
                  <a:solidFill>
                    <a:srgbClr val="000000"/>
                  </a:solidFill>
                  <a:latin typeface="Calibri"/>
                </a:rPr>
                <a:t>ATM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" name="CasellaDiTesto 16"/>
            <p:cNvSpPr/>
            <p:nvPr/>
          </p:nvSpPr>
          <p:spPr>
            <a:xfrm>
              <a:off x="2844000" y="6911280"/>
              <a:ext cx="15220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it-IT" sz="1400" spc="-1" strike="noStrike">
                  <a:solidFill>
                    <a:srgbClr val="000000"/>
                  </a:solidFill>
                  <a:latin typeface="Calibri"/>
                </a:rPr>
                <a:t>PARP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56" name="Picture 2" descr=""/>
            <p:cNvPicPr/>
            <p:nvPr/>
          </p:nvPicPr>
          <p:blipFill>
            <a:blip r:embed="rId5"/>
            <a:srcRect l="27031" t="0" r="24754" b="0"/>
            <a:stretch/>
          </p:blipFill>
          <p:spPr>
            <a:xfrm>
              <a:off x="1053720" y="4660560"/>
              <a:ext cx="1771560" cy="82872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57" name="Picture 6" descr=""/>
            <p:cNvPicPr/>
            <p:nvPr/>
          </p:nvPicPr>
          <p:blipFill>
            <a:blip r:embed="rId6"/>
            <a:srcRect l="28648" t="0" r="22907" b="0"/>
            <a:stretch/>
          </p:blipFill>
          <p:spPr>
            <a:xfrm>
              <a:off x="1053720" y="5573520"/>
              <a:ext cx="1756440" cy="78264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sp>
          <p:nvSpPr>
            <p:cNvPr id="58" name="CasellaDiTesto 46"/>
            <p:cNvSpPr/>
            <p:nvPr/>
          </p:nvSpPr>
          <p:spPr>
            <a:xfrm>
              <a:off x="2844000" y="8579160"/>
              <a:ext cx="1987200" cy="283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70200" rIns="70200" tIns="34920" bIns="3492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it-IT" sz="14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Tubulin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59" name="Immagine 404" descr=""/>
            <p:cNvPicPr/>
            <p:nvPr/>
          </p:nvPicPr>
          <p:blipFill>
            <a:blip r:embed="rId7"/>
            <a:srcRect l="25545" t="43" r="26656" b="2697"/>
            <a:stretch/>
          </p:blipFill>
          <p:spPr>
            <a:xfrm>
              <a:off x="1053720" y="6438240"/>
              <a:ext cx="1756440" cy="121680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sp>
          <p:nvSpPr>
            <p:cNvPr id="60" name="CasellaDiTesto 405"/>
            <p:cNvSpPr/>
            <p:nvPr/>
          </p:nvSpPr>
          <p:spPr>
            <a:xfrm>
              <a:off x="480240" y="6697800"/>
              <a:ext cx="748440" cy="222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70200" rIns="70200" tIns="34920" bIns="3492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116 kDa 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" name="CasellaDiTesto 406"/>
            <p:cNvSpPr/>
            <p:nvPr/>
          </p:nvSpPr>
          <p:spPr>
            <a:xfrm>
              <a:off x="573120" y="7228080"/>
              <a:ext cx="659520" cy="222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70200" rIns="70200" tIns="34920" bIns="3492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98 kD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" name="CasellaDiTesto 409"/>
            <p:cNvSpPr/>
            <p:nvPr/>
          </p:nvSpPr>
          <p:spPr>
            <a:xfrm>
              <a:off x="546480" y="5622840"/>
              <a:ext cx="682560" cy="222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70200" rIns="70200" tIns="34920" bIns="3492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19 kDa 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" name="CasellaDiTesto 410"/>
            <p:cNvSpPr/>
            <p:nvPr/>
          </p:nvSpPr>
          <p:spPr>
            <a:xfrm>
              <a:off x="546480" y="5999040"/>
              <a:ext cx="749880" cy="222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70200" rIns="70200" tIns="34920" bIns="3492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17 kD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" name="CasellaDiTesto 413"/>
            <p:cNvSpPr/>
            <p:nvPr/>
          </p:nvSpPr>
          <p:spPr>
            <a:xfrm>
              <a:off x="546480" y="4786200"/>
              <a:ext cx="682560" cy="222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70200" rIns="70200" tIns="34920" bIns="3492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55 kDa 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5" name="CasellaDiTesto 414"/>
            <p:cNvSpPr/>
            <p:nvPr/>
          </p:nvSpPr>
          <p:spPr>
            <a:xfrm>
              <a:off x="547920" y="5141520"/>
              <a:ext cx="722880" cy="222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70200" rIns="70200" tIns="34920" bIns="3492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43 kD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6" name="CasellaDiTesto 27"/>
            <p:cNvSpPr/>
            <p:nvPr/>
          </p:nvSpPr>
          <p:spPr>
            <a:xfrm>
              <a:off x="2844000" y="5835600"/>
              <a:ext cx="15220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it-IT" sz="1400" spc="-1" strike="noStrike">
                  <a:solidFill>
                    <a:srgbClr val="000000"/>
                  </a:solidFill>
                  <a:latin typeface="Calibri"/>
                </a:rPr>
                <a:t>Caspase 3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7" name="CasellaDiTesto 28"/>
            <p:cNvSpPr/>
            <p:nvPr/>
          </p:nvSpPr>
          <p:spPr>
            <a:xfrm>
              <a:off x="2844000" y="4930920"/>
              <a:ext cx="15220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it-IT" sz="1400" spc="-1" strike="noStrike">
                  <a:solidFill>
                    <a:srgbClr val="000000"/>
                  </a:solidFill>
                  <a:latin typeface="Calibri"/>
                </a:rPr>
                <a:t>Caspase 8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8" name="CasellaDiTesto 29"/>
            <p:cNvSpPr/>
            <p:nvPr/>
          </p:nvSpPr>
          <p:spPr>
            <a:xfrm>
              <a:off x="137160" y="817920"/>
              <a:ext cx="5040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it-IT" sz="1800" spc="-1" strike="noStrike">
                  <a:solidFill>
                    <a:srgbClr val="000000"/>
                  </a:solidFill>
                  <a:latin typeface="Calibri"/>
                </a:rPr>
                <a:t>A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9" name="CasellaDiTesto 30"/>
            <p:cNvSpPr/>
            <p:nvPr/>
          </p:nvSpPr>
          <p:spPr>
            <a:xfrm>
              <a:off x="3340440" y="823320"/>
              <a:ext cx="5040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it-IT" sz="1800" spc="-1" strike="noStrike">
                  <a:solidFill>
                    <a:srgbClr val="000000"/>
                  </a:solidFill>
                  <a:latin typeface="Calibri"/>
                </a:rPr>
                <a:t>B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1-23T09:37:24Z</dcterms:created>
  <dc:creator>Elisabetta Volpe</dc:creator>
  <dc:description/>
  <dc:language>en-US</dc:language>
  <cp:lastModifiedBy>ravikumar.n</cp:lastModifiedBy>
  <dcterms:modified xsi:type="dcterms:W3CDTF">2015-04-16T17:06:22Z</dcterms:modified>
  <cp:revision>2</cp:revision>
  <dc:subject/>
  <dc:title>Presentazione di PowerPoint</dc:title>
</cp:coreProperties>
</file>